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4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96" y="5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0765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329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698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245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148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48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0772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8938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1708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585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641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A2851-6D17-4468-8E05-FBFAE7CCC8B9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717B4-6FB2-4779-8A61-73ED457628BB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7117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3" Type="http://schemas.openxmlformats.org/officeDocument/2006/relationships/image" Target="../media/image31.emf"/><Relationship Id="rId7" Type="http://schemas.openxmlformats.org/officeDocument/2006/relationships/image" Target="../media/image35.emf"/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emf"/><Relationship Id="rId5" Type="http://schemas.openxmlformats.org/officeDocument/2006/relationships/image" Target="../media/image33.emf"/><Relationship Id="rId4" Type="http://schemas.openxmlformats.org/officeDocument/2006/relationships/image" Target="../media/image32.emf"/><Relationship Id="rId9" Type="http://schemas.openxmlformats.org/officeDocument/2006/relationships/image" Target="../media/image3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7" Type="http://schemas.openxmlformats.org/officeDocument/2006/relationships/image" Target="../media/image45.emf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emf"/><Relationship Id="rId5" Type="http://schemas.openxmlformats.org/officeDocument/2006/relationships/image" Target="../media/image43.emf"/><Relationship Id="rId4" Type="http://schemas.openxmlformats.org/officeDocument/2006/relationships/image" Target="../media/image42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2524837" y="221665"/>
            <a:ext cx="1774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Arial" pitchFamily="34" charset="0"/>
                <a:cs typeface="Arial" pitchFamily="34" charset="0"/>
              </a:rPr>
              <a:t>MCAS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5254388" y="221665"/>
            <a:ext cx="18697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Arial" pitchFamily="34" charset="0"/>
                <a:cs typeface="Arial" pitchFamily="34" charset="0"/>
              </a:rPr>
              <a:t>EFO27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7983941" y="221665"/>
            <a:ext cx="1787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Arial" pitchFamily="34" charset="0"/>
                <a:cs typeface="Arial" pitchFamily="34" charset="0"/>
              </a:rPr>
              <a:t>JHOM1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2576252" y="479622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24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hrs</a:t>
            </a:r>
            <a:r>
              <a:rPr lang="it-IT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3686754" y="479622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48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hrs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CasellaDiTesto 58"/>
          <p:cNvSpPr txBox="1"/>
          <p:nvPr/>
        </p:nvSpPr>
        <p:spPr>
          <a:xfrm>
            <a:off x="2792670" y="3480222"/>
            <a:ext cx="985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DNA </a:t>
            </a:r>
            <a:r>
              <a:rPr lang="it-IT" sz="1200" dirty="0" err="1"/>
              <a:t>content</a:t>
            </a:r>
            <a:endParaRPr lang="en-GB" sz="1200" dirty="0"/>
          </a:p>
        </p:txBody>
      </p:sp>
      <p:sp>
        <p:nvSpPr>
          <p:cNvPr id="60" name="CasellaDiTesto 59"/>
          <p:cNvSpPr txBox="1"/>
          <p:nvPr/>
        </p:nvSpPr>
        <p:spPr>
          <a:xfrm>
            <a:off x="5542269" y="3480222"/>
            <a:ext cx="985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DNA </a:t>
            </a:r>
            <a:r>
              <a:rPr lang="it-IT" sz="1200" dirty="0" err="1"/>
              <a:t>content</a:t>
            </a:r>
            <a:endParaRPr lang="en-GB" sz="1200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8022913" y="3480222"/>
            <a:ext cx="985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DNA </a:t>
            </a:r>
            <a:r>
              <a:rPr lang="it-IT" sz="1200" dirty="0" err="1"/>
              <a:t>content</a:t>
            </a:r>
            <a:endParaRPr lang="en-GB" sz="1200" dirty="0"/>
          </a:p>
        </p:txBody>
      </p:sp>
      <p:pic>
        <p:nvPicPr>
          <p:cNvPr id="4" name="Immagine 3"/>
          <p:cNvPicPr>
            <a:picLocks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57815" y="4297111"/>
            <a:ext cx="3763835" cy="2207620"/>
          </a:xfrm>
          <a:prstGeom prst="rect">
            <a:avLst/>
          </a:prstGeom>
        </p:spPr>
      </p:pic>
      <p:pic>
        <p:nvPicPr>
          <p:cNvPr id="5" name="Immagine 4"/>
          <p:cNvPicPr>
            <a:picLocks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413273" y="4297111"/>
            <a:ext cx="3758522" cy="2209942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1586704" y="7365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Immagine 14"/>
          <p:cNvPicPr>
            <a:picLocks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246899" y="4297111"/>
            <a:ext cx="3758522" cy="2209942"/>
          </a:xfrm>
          <a:prstGeom prst="rect">
            <a:avLst/>
          </a:prstGeom>
        </p:spPr>
      </p:pic>
      <p:sp>
        <p:nvSpPr>
          <p:cNvPr id="58" name="CasellaDiTesto 57"/>
          <p:cNvSpPr txBox="1"/>
          <p:nvPr/>
        </p:nvSpPr>
        <p:spPr>
          <a:xfrm>
            <a:off x="285187" y="39101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209890" y="682863"/>
            <a:ext cx="1152000" cy="15317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315359" y="682863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209890" y="2238707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3315359" y="2238707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4994039" y="682863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6099507" y="682863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4994039" y="2238707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6099507" y="2238707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7669007" y="682863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8774464" y="682863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7669007" y="2238707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8774464" y="2238707"/>
            <a:ext cx="1152000" cy="15317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5" name="CasellaDiTesto 64"/>
          <p:cNvSpPr txBox="1"/>
          <p:nvPr/>
        </p:nvSpPr>
        <p:spPr>
          <a:xfrm>
            <a:off x="5349068" y="481894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24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hrs</a:t>
            </a:r>
            <a:r>
              <a:rPr lang="it-IT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CasellaDiTesto 65"/>
          <p:cNvSpPr txBox="1"/>
          <p:nvPr/>
        </p:nvSpPr>
        <p:spPr>
          <a:xfrm>
            <a:off x="6459570" y="481894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48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hrs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CasellaDiTesto 66"/>
          <p:cNvSpPr txBox="1"/>
          <p:nvPr/>
        </p:nvSpPr>
        <p:spPr>
          <a:xfrm>
            <a:off x="8024076" y="481894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24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hrs</a:t>
            </a:r>
            <a:r>
              <a:rPr lang="it-IT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CasellaDiTesto 67"/>
          <p:cNvSpPr txBox="1"/>
          <p:nvPr/>
        </p:nvSpPr>
        <p:spPr>
          <a:xfrm>
            <a:off x="9134578" y="481894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48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hrs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1659536" y="117108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CTRL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4479902" y="117108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CTRL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7190780" y="117108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CTRL</a:t>
            </a:r>
          </a:p>
        </p:txBody>
      </p:sp>
      <p:sp>
        <p:nvSpPr>
          <p:cNvPr id="17" name="CasellaDiTesto 16"/>
          <p:cNvSpPr txBox="1"/>
          <p:nvPr/>
        </p:nvSpPr>
        <p:spPr>
          <a:xfrm>
            <a:off x="1646712" y="2792386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50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nM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4424598" y="2792386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250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nM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7177956" y="2792386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itchFamily="34" charset="0"/>
                <a:cs typeface="Arial" pitchFamily="34" charset="0"/>
              </a:rPr>
              <a:t>50 </a:t>
            </a:r>
            <a:r>
              <a:rPr lang="it-IT" sz="1200" dirty="0" err="1" smtClean="0">
                <a:latin typeface="Arial" pitchFamily="34" charset="0"/>
                <a:cs typeface="Arial" pitchFamily="34" charset="0"/>
              </a:rPr>
              <a:t>nM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Rectangle 34"/>
          <p:cNvSpPr>
            <a:spLocks noChangeArrowheads="1"/>
          </p:cNvSpPr>
          <p:nvPr/>
        </p:nvSpPr>
        <p:spPr bwMode="auto">
          <a:xfrm>
            <a:off x="2514599" y="3769252"/>
            <a:ext cx="726757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NA </a:t>
            </a:r>
            <a:r>
              <a:rPr kumimoji="0" lang="it-IT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ontent</a:t>
            </a:r>
            <a:r>
              <a:rPr lang="it-IT" sz="12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endParaRPr kumimoji="0" lang="it-IT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Rectangle 34"/>
          <p:cNvSpPr>
            <a:spLocks noChangeArrowheads="1"/>
          </p:cNvSpPr>
          <p:nvPr/>
        </p:nvSpPr>
        <p:spPr bwMode="auto">
          <a:xfrm rot="16200000">
            <a:off x="745046" y="2055438"/>
            <a:ext cx="282915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umber</a:t>
            </a:r>
            <a:r>
              <a:rPr kumimoji="0" lang="it-IT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it-IT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f</a:t>
            </a:r>
            <a:r>
              <a:rPr kumimoji="0" lang="it-IT" sz="12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it-IT" sz="1200" b="1" i="0" u="none" strike="noStrike" cap="none" normalizeH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ells</a:t>
            </a:r>
            <a:endParaRPr kumimoji="0" lang="it-IT" sz="3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Rettangolo 48"/>
          <p:cNvSpPr/>
          <p:nvPr/>
        </p:nvSpPr>
        <p:spPr>
          <a:xfrm>
            <a:off x="97776" y="6462013"/>
            <a:ext cx="21541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4087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140443" y="6239446"/>
            <a:ext cx="21541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0787" y="515611"/>
            <a:ext cx="3270172" cy="234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9962" y="515611"/>
            <a:ext cx="3270172" cy="23400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59669" y="515611"/>
            <a:ext cx="3240160" cy="234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0787" y="3377528"/>
            <a:ext cx="3367678" cy="2340000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69962" y="3377528"/>
            <a:ext cx="3292673" cy="2340000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07156" y="3377528"/>
            <a:ext cx="3292673" cy="23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338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CasellaDiTesto 14"/>
          <p:cNvSpPr txBox="1"/>
          <p:nvPr/>
        </p:nvSpPr>
        <p:spPr>
          <a:xfrm>
            <a:off x="515465" y="2283936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515465" y="82090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515465" y="4658367"/>
            <a:ext cx="3593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ttangolo 21"/>
          <p:cNvSpPr/>
          <p:nvPr/>
        </p:nvSpPr>
        <p:spPr>
          <a:xfrm>
            <a:off x="209579" y="6552129"/>
            <a:ext cx="17749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3. </a:t>
            </a:r>
            <a:endParaRPr lang="en-GB" sz="1200" dirty="0">
              <a:latin typeface="Times New Roman"/>
              <a:cs typeface="Times New Roman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8177291" y="219931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8177290" y="3324538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magine 3"/>
          <p:cNvPicPr>
            <a:picLocks/>
          </p:cNvPicPr>
          <p:nvPr/>
        </p:nvPicPr>
        <p:blipFill rotWithShape="1">
          <a:blip r:embed="rId2"/>
          <a:srcRect l="1650" t="1408" r="947" b="1706"/>
          <a:stretch/>
        </p:blipFill>
        <p:spPr>
          <a:xfrm>
            <a:off x="8352211" y="608687"/>
            <a:ext cx="3600000" cy="2160000"/>
          </a:xfrm>
          <a:prstGeom prst="rect">
            <a:avLst/>
          </a:prstGeom>
        </p:spPr>
      </p:pic>
      <p:pic>
        <p:nvPicPr>
          <p:cNvPr id="5" name="Immagine 4"/>
          <p:cNvPicPr>
            <a:picLocks/>
          </p:cNvPicPr>
          <p:nvPr/>
        </p:nvPicPr>
        <p:blipFill rotWithShape="1">
          <a:blip r:embed="rId3"/>
          <a:srcRect l="1250" t="1853" r="1086" b="1068"/>
          <a:stretch/>
        </p:blipFill>
        <p:spPr>
          <a:xfrm>
            <a:off x="8352211" y="3746309"/>
            <a:ext cx="3600000" cy="2160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7963" y="2269515"/>
            <a:ext cx="3024000" cy="2333974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1139" y="0"/>
            <a:ext cx="2960824" cy="23400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94010" y="4533004"/>
            <a:ext cx="2967953" cy="2340000"/>
          </a:xfrm>
          <a:prstGeom prst="rect">
            <a:avLst/>
          </a:prstGeom>
        </p:spPr>
      </p:pic>
      <p:pic>
        <p:nvPicPr>
          <p:cNvPr id="9" name="Immagine 8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634618" y="63040"/>
            <a:ext cx="2988000" cy="2304000"/>
          </a:xfrm>
          <a:prstGeom prst="rect">
            <a:avLst/>
          </a:prstGeom>
        </p:spPr>
      </p:pic>
      <p:pic>
        <p:nvPicPr>
          <p:cNvPr id="11" name="Immagine 10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655271" y="2288565"/>
            <a:ext cx="2988000" cy="2304000"/>
          </a:xfrm>
          <a:prstGeom prst="rect">
            <a:avLst/>
          </a:prstGeom>
        </p:spPr>
      </p:pic>
      <p:pic>
        <p:nvPicPr>
          <p:cNvPr id="20" name="Immagine 1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4700375" y="4595464"/>
            <a:ext cx="3024000" cy="23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2852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ttangolo 10"/>
          <p:cNvSpPr/>
          <p:nvPr/>
        </p:nvSpPr>
        <p:spPr>
          <a:xfrm>
            <a:off x="0" y="6581001"/>
            <a:ext cx="192746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/>
                <a:cs typeface="Times New Roman"/>
              </a:rPr>
              <a:t>Supplementary </a:t>
            </a:r>
            <a:r>
              <a:rPr lang="en-GB" sz="1200" b="1" dirty="0" smtClean="0">
                <a:latin typeface="Times New Roman"/>
                <a:cs typeface="Times New Roman"/>
              </a:rPr>
              <a:t>Fig </a:t>
            </a:r>
            <a:r>
              <a:rPr lang="en-GB" sz="1200" b="1" dirty="0">
                <a:latin typeface="Times New Roman"/>
                <a:cs typeface="Times New Roman"/>
              </a:rPr>
              <a:t>4. </a:t>
            </a:r>
            <a:endParaRPr lang="en-GB" sz="1200" dirty="0">
              <a:latin typeface="Times New Roman"/>
              <a:cs typeface="Times New Roman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142875" y="0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3907562" y="0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81467" y="121652"/>
            <a:ext cx="3221855" cy="2232000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81467" y="2280677"/>
            <a:ext cx="3221855" cy="2232000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061" y="4428714"/>
            <a:ext cx="3223261" cy="22320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5"/>
          <a:srcRect l="1051" t="1880" r="4052" b="2273"/>
          <a:stretch/>
        </p:blipFill>
        <p:spPr>
          <a:xfrm>
            <a:off x="7951166" y="919579"/>
            <a:ext cx="3559433" cy="2340000"/>
          </a:xfrm>
          <a:prstGeom prst="rect">
            <a:avLst/>
          </a:prstGeom>
        </p:spPr>
      </p:pic>
      <p:pic>
        <p:nvPicPr>
          <p:cNvPr id="2" name="Immagine 1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053657" y="121652"/>
            <a:ext cx="3204000" cy="2232000"/>
          </a:xfrm>
          <a:prstGeom prst="rect">
            <a:avLst/>
          </a:prstGeom>
        </p:spPr>
      </p:pic>
      <p:pic>
        <p:nvPicPr>
          <p:cNvPr id="7" name="Immagine 6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053657" y="2280677"/>
            <a:ext cx="3204000" cy="2232000"/>
          </a:xfrm>
          <a:prstGeom prst="rect">
            <a:avLst/>
          </a:prstGeom>
        </p:spPr>
      </p:pic>
      <p:pic>
        <p:nvPicPr>
          <p:cNvPr id="9" name="Immagine 8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053657" y="4428714"/>
            <a:ext cx="3204000" cy="2232000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 rotWithShape="1">
          <a:blip r:embed="rId9"/>
          <a:srcRect l="2345" t="909" r="2946" b="1520"/>
          <a:stretch/>
        </p:blipFill>
        <p:spPr>
          <a:xfrm>
            <a:off x="8051786" y="3724274"/>
            <a:ext cx="3458813" cy="2340000"/>
          </a:xfrm>
          <a:prstGeom prst="rect">
            <a:avLst/>
          </a:prstGeom>
        </p:spPr>
      </p:pic>
      <p:sp>
        <p:nvSpPr>
          <p:cNvPr id="14" name="CasellaDiTesto 13"/>
          <p:cNvSpPr txBox="1"/>
          <p:nvPr/>
        </p:nvSpPr>
        <p:spPr>
          <a:xfrm>
            <a:off x="7707992" y="0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6013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91053" y="6486006"/>
            <a:ext cx="17282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5. 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328" y="1973767"/>
            <a:ext cx="4932091" cy="2770590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91053" y="1133651"/>
            <a:ext cx="2952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5315" y="1472205"/>
            <a:ext cx="4682134" cy="3676207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6050687" y="1133651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97952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367278" y="6181206"/>
            <a:ext cx="17282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434336" y="158639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4588889" y="158639"/>
            <a:ext cx="349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4197611" y="2972034"/>
            <a:ext cx="4511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5522018" y="556258"/>
            <a:ext cx="855023" cy="261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6757051" y="556258"/>
            <a:ext cx="126230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Onvansertib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15nM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8340561" y="556258"/>
            <a:ext cx="1165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Eribulin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0,35nM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9933971" y="556258"/>
            <a:ext cx="9781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Combination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5533893" y="2595410"/>
            <a:ext cx="5355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DNA </a:t>
            </a:r>
            <a:r>
              <a:rPr lang="it-I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ntent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147097" y="743530"/>
            <a:ext cx="1440000" cy="191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639429" y="743530"/>
            <a:ext cx="1440000" cy="191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8131761" y="743530"/>
            <a:ext cx="1440000" cy="191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9624094" y="743530"/>
            <a:ext cx="1440000" cy="191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" name="CasellaDiTesto 24"/>
          <p:cNvSpPr txBox="1"/>
          <p:nvPr/>
        </p:nvSpPr>
        <p:spPr>
          <a:xfrm rot="16200000">
            <a:off x="4281450" y="1406402"/>
            <a:ext cx="15331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3288" y="320564"/>
            <a:ext cx="3494358" cy="3265678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7"/>
          <a:srcRect r="31189"/>
          <a:stretch/>
        </p:blipFill>
        <p:spPr>
          <a:xfrm>
            <a:off x="4271326" y="3064636"/>
            <a:ext cx="3649349" cy="32656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1964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367278" y="6284724"/>
            <a:ext cx="186157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7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6437" y="1319785"/>
            <a:ext cx="6739126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97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98187" y="2067507"/>
            <a:ext cx="6436196" cy="3304593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4491725" y="1863306"/>
            <a:ext cx="92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EFO27</a:t>
            </a:r>
            <a:endParaRPr lang="en-GB" b="1" dirty="0"/>
          </a:p>
        </p:txBody>
      </p:sp>
      <p:sp>
        <p:nvSpPr>
          <p:cNvPr id="4" name="Rettangolo 3"/>
          <p:cNvSpPr/>
          <p:nvPr/>
        </p:nvSpPr>
        <p:spPr>
          <a:xfrm>
            <a:off x="424428" y="6103749"/>
            <a:ext cx="174727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 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74182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94</Words>
  <Application>Microsoft Office PowerPoint</Application>
  <PresentationFormat>Widescreen</PresentationFormat>
  <Paragraphs>50</Paragraphs>
  <Slides>8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berta Affatato</dc:creator>
  <cp:lastModifiedBy>GD</cp:lastModifiedBy>
  <cp:revision>26</cp:revision>
  <dcterms:created xsi:type="dcterms:W3CDTF">2019-11-19T17:08:23Z</dcterms:created>
  <dcterms:modified xsi:type="dcterms:W3CDTF">2020-02-21T07:45:51Z</dcterms:modified>
</cp:coreProperties>
</file>